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A9224E-79B3-42AF-99F3-E0BB007077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556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85A8E-2019-4037-BFCB-46D14705BB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06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69F419-E943-4B79-AF08-88A8F7C714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08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536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08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536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25F07-5093-43E9-A89D-5F2D7BAA0B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7F3E33-E5B1-474B-B12D-274269BBDE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9F2DB-B646-4EFA-B2F0-68CBFE694C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E73B4-CA4F-4BB0-A0D0-D54AA8281A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33647-CC4E-449D-8007-808B923209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920"/>
            <a:ext cx="5827680" cy="764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ABF05A-150A-4FB4-869B-6A75CAB99F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76696-9C92-4E5B-A700-E425436759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06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E986DB-AFC9-4E0F-824F-1DDBEE42AA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088138-1559-4A87-A675-C65B66BDED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440" y="9024840"/>
            <a:ext cx="1427040" cy="65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840"/>
            <a:ext cx="2170080" cy="65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840"/>
            <a:ext cx="1427040" cy="65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731D9A1A-0D98-42A0-B29A-0FF6A4FFFFB1}" type="slidenum"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922320" y="4160880"/>
            <a:ext cx="5081400" cy="2789640"/>
            <a:chOff x="922320" y="4160880"/>
            <a:chExt cx="5081400" cy="2789640"/>
          </a:xfrm>
        </p:grpSpPr>
        <p:sp>
          <p:nvSpPr>
            <p:cNvPr id="42" name=""/>
            <p:cNvSpPr/>
            <p:nvPr/>
          </p:nvSpPr>
          <p:spPr>
            <a:xfrm>
              <a:off x="2751840" y="6704280"/>
              <a:ext cx="181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Number of ESTs per conti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1212840" y="4447800"/>
              <a:ext cx="4790880" cy="2225880"/>
              <a:chOff x="1212840" y="4447800"/>
              <a:chExt cx="4790880" cy="2225880"/>
            </a:xfrm>
          </p:grpSpPr>
          <p:sp>
            <p:nvSpPr>
              <p:cNvPr id="44" name=""/>
              <p:cNvSpPr/>
              <p:nvPr/>
            </p:nvSpPr>
            <p:spPr>
              <a:xfrm>
                <a:off x="1590480" y="4810680"/>
                <a:ext cx="115200" cy="169776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1806120" y="5663520"/>
                <a:ext cx="115560" cy="84492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2030040" y="5971320"/>
                <a:ext cx="115560" cy="53748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2244240" y="6125040"/>
                <a:ext cx="115560" cy="38340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459880" y="6228000"/>
                <a:ext cx="115560" cy="28188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683800" y="6278760"/>
                <a:ext cx="115560" cy="23004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898000" y="6312240"/>
                <a:ext cx="115560" cy="19656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3114000" y="6355080"/>
                <a:ext cx="115560" cy="15372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337920" y="6397560"/>
                <a:ext cx="115560" cy="11088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552120" y="6405480"/>
                <a:ext cx="115560" cy="10296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3775680" y="6423120"/>
                <a:ext cx="115560" cy="8532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8520" bIns="385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3991320" y="6440400"/>
                <a:ext cx="115560" cy="6804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1240" bIns="212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4205880" y="6458040"/>
                <a:ext cx="115560" cy="5040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4429800" y="6458040"/>
                <a:ext cx="115200" cy="5040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4645440" y="6458040"/>
                <a:ext cx="115560" cy="5040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4859640" y="6465960"/>
                <a:ext cx="115200" cy="4248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4320" bIns="-43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5083200" y="6483240"/>
                <a:ext cx="115560" cy="2520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0" bIns="-21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5299200" y="6483240"/>
                <a:ext cx="115560" cy="2520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0" bIns="-21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5513400" y="6483240"/>
                <a:ext cx="115560" cy="2520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0" bIns="-21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5737320" y="6337440"/>
                <a:ext cx="115560" cy="17136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639440" y="6057000"/>
                <a:ext cx="115560" cy="451800"/>
              </a:xfrm>
              <a:prstGeom prst="rect">
                <a:avLst/>
              </a:prstGeom>
              <a:solidFill>
                <a:srgbClr val="5f5f5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1855440" y="6337440"/>
                <a:ext cx="115560" cy="171360"/>
              </a:xfrm>
              <a:prstGeom prst="rect">
                <a:avLst/>
              </a:prstGeom>
              <a:solidFill>
                <a:srgbClr val="5f5f5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079360" y="6432480"/>
                <a:ext cx="115560" cy="77400"/>
              </a:xfrm>
              <a:prstGeom prst="rect">
                <a:avLst/>
              </a:prstGeom>
              <a:solidFill>
                <a:srgbClr val="5f5f5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0600" bIns="30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293560" y="6465960"/>
                <a:ext cx="115560" cy="42480"/>
              </a:xfrm>
              <a:prstGeom prst="rect">
                <a:avLst/>
              </a:prstGeom>
              <a:solidFill>
                <a:srgbClr val="5f5f5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4320" bIns="-43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509200" y="6483240"/>
                <a:ext cx="115560" cy="25200"/>
              </a:xfrm>
              <a:prstGeom prst="rect">
                <a:avLst/>
              </a:prstGeom>
              <a:solidFill>
                <a:srgbClr val="5f5f5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0" bIns="-21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733120" y="6491160"/>
                <a:ext cx="115200" cy="17280"/>
              </a:xfrm>
              <a:prstGeom prst="rect">
                <a:avLst/>
              </a:prstGeom>
              <a:solidFill>
                <a:srgbClr val="5f5f5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9520" bIns="-295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947320" y="6491160"/>
                <a:ext cx="115560" cy="17280"/>
              </a:xfrm>
              <a:prstGeom prst="rect">
                <a:avLst/>
              </a:prstGeom>
              <a:solidFill>
                <a:srgbClr val="5f5f5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9520" bIns="-295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3163320" y="6500880"/>
                <a:ext cx="115200" cy="7560"/>
              </a:xfrm>
              <a:prstGeom prst="rect">
                <a:avLst/>
              </a:prstGeom>
              <a:solidFill>
                <a:srgbClr val="5f5f5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9240" bIns="-392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3386880" y="6500880"/>
                <a:ext cx="115560" cy="756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9240" bIns="-392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3602880" y="6500880"/>
                <a:ext cx="115560" cy="756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9240" bIns="-392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5786640" y="6500880"/>
                <a:ext cx="115560" cy="756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9240" bIns="-392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434600" y="6507000"/>
                <a:ext cx="6156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434600" y="6294600"/>
                <a:ext cx="6156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1434600" y="6072840"/>
                <a:ext cx="61560" cy="1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434600" y="5858640"/>
                <a:ext cx="61560" cy="1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1434600" y="5636520"/>
                <a:ext cx="6156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1434600" y="5424120"/>
                <a:ext cx="6156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1434600" y="5202360"/>
                <a:ext cx="61560" cy="1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1434600" y="4989960"/>
                <a:ext cx="6156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1434600" y="4767840"/>
                <a:ext cx="61560" cy="1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1434600" y="4553640"/>
                <a:ext cx="6156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flipV="1">
                <a:off x="155700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flipV="1">
                <a:off x="178092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flipV="1">
                <a:off x="2004480" y="6506640"/>
                <a:ext cx="144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 flipV="1">
                <a:off x="221904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 flipV="1">
                <a:off x="243468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 flipV="1">
                <a:off x="2658240" y="6506640"/>
                <a:ext cx="144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 flipV="1">
                <a:off x="287424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 flipV="1">
                <a:off x="3088440" y="6506640"/>
                <a:ext cx="144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 flipV="1">
                <a:off x="3312360" y="6506640"/>
                <a:ext cx="144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 flipV="1">
                <a:off x="352836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 flipV="1">
                <a:off x="3750120" y="6506640"/>
                <a:ext cx="144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V="1">
                <a:off x="396612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 flipV="1">
                <a:off x="418212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flipV="1">
                <a:off x="440424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 flipV="1">
                <a:off x="462024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flipV="1">
                <a:off x="4835520" y="6506640"/>
                <a:ext cx="144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 flipV="1">
                <a:off x="5059440" y="6506640"/>
                <a:ext cx="144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527400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 flipV="1">
                <a:off x="5489640" y="6506640"/>
                <a:ext cx="144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V="1">
                <a:off x="5713560" y="6506640"/>
                <a:ext cx="108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 flipV="1">
                <a:off x="5927760" y="6506640"/>
                <a:ext cx="1440" cy="36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1360080" y="64562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1212840" y="6020280"/>
                <a:ext cx="226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1212840" y="5585760"/>
                <a:ext cx="226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20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1212840" y="5151600"/>
                <a:ext cx="226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30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1212840" y="4715640"/>
                <a:ext cx="226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40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1648800" y="6551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1871280" y="6551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2087280" y="6551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2302920" y="6551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2525040" y="6551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2740680" y="6551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956680" y="6551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180600" y="6551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336276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57732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80052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401508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423072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445464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466884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488448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510840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532260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1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5538600" y="6551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5729400" y="6551640"/>
                <a:ext cx="172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&gt;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1499760" y="4447800"/>
                <a:ext cx="4503960" cy="206424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501080" y="4676040"/>
                <a:ext cx="186840" cy="129960"/>
              </a:xfrm>
              <a:prstGeom prst="rect">
                <a:avLst/>
              </a:prstGeom>
              <a:solidFill>
                <a:srgbClr val="dddddd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501080" y="4852080"/>
                <a:ext cx="186840" cy="128160"/>
              </a:xfrm>
              <a:prstGeom prst="rect">
                <a:avLst/>
              </a:prstGeom>
              <a:solidFill>
                <a:srgbClr val="5f5f5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4636080" y="4641120"/>
                <a:ext cx="11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Number of unigenes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636080" y="4812120"/>
                <a:ext cx="1366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s-ES_tradnl" sz="800" spc="-1" strike="noStrike">
                    <a:solidFill>
                      <a:srgbClr val="000000"/>
                    </a:solidFill>
                    <a:latin typeface="Arial"/>
                  </a:rPr>
                  <a:t>Number of unigenes C3*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36" name=""/>
            <p:cNvSpPr/>
            <p:nvPr/>
          </p:nvSpPr>
          <p:spPr>
            <a:xfrm rot="16200000">
              <a:off x="342360" y="5533560"/>
              <a:ext cx="1406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Number of unigene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427040" y="4160880"/>
              <a:ext cx="1195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3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38" name=""/>
          <p:cNvGrpSpPr/>
          <p:nvPr/>
        </p:nvGrpSpPr>
        <p:grpSpPr>
          <a:xfrm>
            <a:off x="1982880" y="1712880"/>
            <a:ext cx="2959920" cy="2332440"/>
            <a:chOff x="1982880" y="1712880"/>
            <a:chExt cx="2959920" cy="2332440"/>
          </a:xfrm>
        </p:grpSpPr>
        <p:sp>
          <p:nvSpPr>
            <p:cNvPr id="139" name=""/>
            <p:cNvSpPr/>
            <p:nvPr/>
          </p:nvSpPr>
          <p:spPr>
            <a:xfrm>
              <a:off x="2655720" y="3316680"/>
              <a:ext cx="171720" cy="18720"/>
            </a:xfrm>
            <a:prstGeom prst="rect">
              <a:avLst/>
            </a:prstGeom>
            <a:solidFill>
              <a:srgbClr val="5f5f5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080" bIns="-280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932200" y="3316680"/>
              <a:ext cx="162000" cy="18720"/>
            </a:xfrm>
            <a:prstGeom prst="rect">
              <a:avLst/>
            </a:prstGeom>
            <a:solidFill>
              <a:srgbClr val="5f5f5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080" bIns="-280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3198960" y="3297600"/>
              <a:ext cx="171360" cy="37800"/>
            </a:xfrm>
            <a:prstGeom prst="rect">
              <a:avLst/>
            </a:prstGeom>
            <a:solidFill>
              <a:srgbClr val="5f5f5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000" bIns="-90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475080" y="3269160"/>
              <a:ext cx="171360" cy="66240"/>
            </a:xfrm>
            <a:prstGeom prst="rect">
              <a:avLst/>
            </a:prstGeom>
            <a:solidFill>
              <a:srgbClr val="5f5f5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440" bIns="19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751200" y="3231000"/>
              <a:ext cx="162000" cy="104400"/>
            </a:xfrm>
            <a:prstGeom prst="rect">
              <a:avLst/>
            </a:prstGeom>
            <a:solidFill>
              <a:srgbClr val="5f5f5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4017960" y="2440800"/>
              <a:ext cx="171360" cy="894600"/>
            </a:xfrm>
            <a:prstGeom prst="rect">
              <a:avLst/>
            </a:prstGeom>
            <a:solidFill>
              <a:srgbClr val="5f5f5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4294080" y="2231640"/>
              <a:ext cx="162000" cy="1104120"/>
            </a:xfrm>
            <a:prstGeom prst="rect">
              <a:avLst/>
            </a:prstGeom>
            <a:solidFill>
              <a:srgbClr val="5f5f5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508120" y="3335760"/>
              <a:ext cx="540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2508120" y="3126240"/>
              <a:ext cx="540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2508120" y="2926440"/>
              <a:ext cx="5400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508120" y="2716920"/>
              <a:ext cx="540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508120" y="2507400"/>
              <a:ext cx="540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508120" y="2307600"/>
              <a:ext cx="5400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2508120" y="2098440"/>
              <a:ext cx="5400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2608200" y="3333960"/>
              <a:ext cx="1800" cy="6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2884320" y="3333960"/>
              <a:ext cx="1800" cy="6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3151080" y="3333960"/>
              <a:ext cx="1800" cy="6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3427560" y="3333960"/>
              <a:ext cx="1440" cy="6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"/>
            <p:cNvSpPr/>
            <p:nvPr/>
          </p:nvSpPr>
          <p:spPr>
            <a:xfrm flipV="1">
              <a:off x="3703680" y="3333960"/>
              <a:ext cx="1440" cy="6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3970440" y="3333960"/>
              <a:ext cx="1440" cy="6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 flipV="1">
              <a:off x="4246560" y="3333960"/>
              <a:ext cx="1440" cy="6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4513320" y="3333960"/>
              <a:ext cx="1440" cy="6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"/>
            <p:cNvSpPr/>
            <p:nvPr/>
          </p:nvSpPr>
          <p:spPr>
            <a:xfrm flipV="1">
              <a:off x="4789440" y="3333960"/>
              <a:ext cx="1800" cy="6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2425680" y="32785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2254320" y="2869560"/>
              <a:ext cx="22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254320" y="2450520"/>
              <a:ext cx="22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2254320" y="2041200"/>
              <a:ext cx="22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60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"/>
            <p:cNvSpPr/>
            <p:nvPr/>
          </p:nvSpPr>
          <p:spPr>
            <a:xfrm rot="18900000">
              <a:off x="2410920" y="3508200"/>
              <a:ext cx="43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100 - 19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 rot="18900000">
              <a:off x="3517560" y="3508200"/>
              <a:ext cx="43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500 - 59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"/>
            <p:cNvSpPr/>
            <p:nvPr/>
          </p:nvSpPr>
          <p:spPr>
            <a:xfrm rot="18900000">
              <a:off x="4055760" y="3508200"/>
              <a:ext cx="43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700 - 79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2570040" y="1993680"/>
              <a:ext cx="2320920" cy="13417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"/>
            <p:cNvSpPr/>
            <p:nvPr/>
          </p:nvSpPr>
          <p:spPr>
            <a:xfrm rot="18900000">
              <a:off x="4316040" y="3508200"/>
              <a:ext cx="43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800 - 89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"/>
            <p:cNvSpPr/>
            <p:nvPr/>
          </p:nvSpPr>
          <p:spPr>
            <a:xfrm rot="18900000">
              <a:off x="3777840" y="3508200"/>
              <a:ext cx="43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600 - 69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"/>
            <p:cNvSpPr/>
            <p:nvPr/>
          </p:nvSpPr>
          <p:spPr>
            <a:xfrm rot="18900000">
              <a:off x="3234960" y="3508200"/>
              <a:ext cx="43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400 - 49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"/>
            <p:cNvSpPr/>
            <p:nvPr/>
          </p:nvSpPr>
          <p:spPr>
            <a:xfrm rot="18900000">
              <a:off x="2963520" y="3508200"/>
              <a:ext cx="43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300 - 39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"/>
            <p:cNvSpPr/>
            <p:nvPr/>
          </p:nvSpPr>
          <p:spPr>
            <a:xfrm rot="18900000">
              <a:off x="2698560" y="3508200"/>
              <a:ext cx="43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200 - 29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"/>
            <p:cNvSpPr/>
            <p:nvPr/>
          </p:nvSpPr>
          <p:spPr>
            <a:xfrm rot="16200000">
              <a:off x="1523160" y="2462400"/>
              <a:ext cx="1165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Number of EST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3233160" y="3799080"/>
              <a:ext cx="912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ESTs length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2442960" y="1712880"/>
              <a:ext cx="1195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3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2991240" y="1712880"/>
              <a:ext cx="195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Average EST length is 673 nt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79" name=""/>
          <p:cNvSpPr/>
          <p:nvPr/>
        </p:nvSpPr>
        <p:spPr>
          <a:xfrm>
            <a:off x="835920" y="777960"/>
            <a:ext cx="32594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2" marL="358920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dditional File 2.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nalysis of EST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Distribution of EST length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Distribution of EST number per contig. Analysis of EST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pereza</cp:lastModifiedBy>
  <dcterms:modified xsi:type="dcterms:W3CDTF">2009-09-08T07:18:20Z</dcterms:modified>
  <cp:revision>3</cp:revision>
  <dc:subject/>
  <dc:title>PowerPoint Presentation</dc:title>
</cp:coreProperties>
</file>